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7" d="100"/>
          <a:sy n="77" d="100"/>
        </p:scale>
        <p:origin x="-106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B08B8-B07C-6E4A-BBD3-998069B422D3}" type="datetimeFigureOut">
              <a:rPr lang="en-US" smtClean="0"/>
              <a:t>12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F04C6-310C-B64D-A36A-F0AA3178C8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91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B08B8-B07C-6E4A-BBD3-998069B422D3}" type="datetimeFigureOut">
              <a:rPr lang="en-US" smtClean="0"/>
              <a:t>12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F04C6-310C-B64D-A36A-F0AA3178C8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061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B08B8-B07C-6E4A-BBD3-998069B422D3}" type="datetimeFigureOut">
              <a:rPr lang="en-US" smtClean="0"/>
              <a:t>12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F04C6-310C-B64D-A36A-F0AA3178C8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503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B08B8-B07C-6E4A-BBD3-998069B422D3}" type="datetimeFigureOut">
              <a:rPr lang="en-US" smtClean="0"/>
              <a:t>12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F04C6-310C-B64D-A36A-F0AA3178C8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092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B08B8-B07C-6E4A-BBD3-998069B422D3}" type="datetimeFigureOut">
              <a:rPr lang="en-US" smtClean="0"/>
              <a:t>12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F04C6-310C-B64D-A36A-F0AA3178C8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9896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B08B8-B07C-6E4A-BBD3-998069B422D3}" type="datetimeFigureOut">
              <a:rPr lang="en-US" smtClean="0"/>
              <a:t>12/2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F04C6-310C-B64D-A36A-F0AA3178C8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5129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B08B8-B07C-6E4A-BBD3-998069B422D3}" type="datetimeFigureOut">
              <a:rPr lang="en-US" smtClean="0"/>
              <a:t>12/21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F04C6-310C-B64D-A36A-F0AA3178C8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925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B08B8-B07C-6E4A-BBD3-998069B422D3}" type="datetimeFigureOut">
              <a:rPr lang="en-US" smtClean="0"/>
              <a:t>12/21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F04C6-310C-B64D-A36A-F0AA3178C8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860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B08B8-B07C-6E4A-BBD3-998069B422D3}" type="datetimeFigureOut">
              <a:rPr lang="en-US" smtClean="0"/>
              <a:t>12/21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F04C6-310C-B64D-A36A-F0AA3178C8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458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B08B8-B07C-6E4A-BBD3-998069B422D3}" type="datetimeFigureOut">
              <a:rPr lang="en-US" smtClean="0"/>
              <a:t>12/2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F04C6-310C-B64D-A36A-F0AA3178C8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0468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B08B8-B07C-6E4A-BBD3-998069B422D3}" type="datetimeFigureOut">
              <a:rPr lang="en-US" smtClean="0"/>
              <a:t>12/2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F04C6-310C-B64D-A36A-F0AA3178C8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206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B08B8-B07C-6E4A-BBD3-998069B422D3}" type="datetimeFigureOut">
              <a:rPr lang="en-US" smtClean="0"/>
              <a:t>12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DF04C6-310C-B64D-A36A-F0AA3178C8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379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Relationship Id="rId3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5109" y="976724"/>
            <a:ext cx="4603581" cy="304817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055632" y="4717710"/>
            <a:ext cx="49832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6 </a:t>
            </a:r>
          </a:p>
          <a:p>
            <a:r>
              <a:rPr lang="en-US" dirty="0" smtClean="0"/>
              <a:t>DAPI-stained chromosomes for figure s6 (a) and (b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857275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8273" y="802873"/>
            <a:ext cx="2751579" cy="347386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40948" y="802873"/>
            <a:ext cx="2751579" cy="347386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55632" y="4503277"/>
            <a:ext cx="73031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SH image of LTR region in VUH2_81M23 on mitotic metaphase chromosomes showing </a:t>
            </a:r>
            <a:r>
              <a:rPr lang="en-US" dirty="0" err="1" smtClean="0"/>
              <a:t>pericentromeric</a:t>
            </a:r>
            <a:r>
              <a:rPr lang="en-US" dirty="0" smtClean="0"/>
              <a:t> distribution</a:t>
            </a:r>
          </a:p>
        </p:txBody>
      </p:sp>
    </p:spTree>
    <p:extLst>
      <p:ext uri="{BB962C8B-B14F-4D97-AF65-F5344CB8AC3E}">
        <p14:creationId xmlns:p14="http://schemas.microsoft.com/office/powerpoint/2010/main" val="4151836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1</Words>
  <Application>Microsoft Macintosh PowerPoint</Application>
  <PresentationFormat>On-screen Show (4:3)</PresentationFormat>
  <Paragraphs>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ko  Iwata</dc:creator>
  <cp:lastModifiedBy>Aiko  Iwata</cp:lastModifiedBy>
  <cp:revision>4</cp:revision>
  <dcterms:created xsi:type="dcterms:W3CDTF">2015-12-20T16:35:07Z</dcterms:created>
  <dcterms:modified xsi:type="dcterms:W3CDTF">2015-12-21T18:19:08Z</dcterms:modified>
</cp:coreProperties>
</file>